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58" r:id="rId4"/>
  </p:sldIdLst>
  <p:sldSz cx="6858000" cy="12192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61" d="100"/>
          <a:sy n="61" d="100"/>
        </p:scale>
        <p:origin x="333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about:blank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Irradiancia Algameca'!$A$68:$A$468</c:f>
              <c:numCache>
                <c:formatCode>General</c:formatCode>
                <c:ptCount val="401"/>
                <c:pt idx="0">
                  <c:v>380</c:v>
                </c:pt>
                <c:pt idx="1">
                  <c:v>381</c:v>
                </c:pt>
                <c:pt idx="2">
                  <c:v>382</c:v>
                </c:pt>
                <c:pt idx="3">
                  <c:v>383</c:v>
                </c:pt>
                <c:pt idx="4">
                  <c:v>384</c:v>
                </c:pt>
                <c:pt idx="5">
                  <c:v>385</c:v>
                </c:pt>
                <c:pt idx="6">
                  <c:v>386</c:v>
                </c:pt>
                <c:pt idx="7">
                  <c:v>387</c:v>
                </c:pt>
                <c:pt idx="8">
                  <c:v>388</c:v>
                </c:pt>
                <c:pt idx="9">
                  <c:v>389</c:v>
                </c:pt>
                <c:pt idx="10">
                  <c:v>390</c:v>
                </c:pt>
                <c:pt idx="11">
                  <c:v>391</c:v>
                </c:pt>
                <c:pt idx="12">
                  <c:v>392</c:v>
                </c:pt>
                <c:pt idx="13">
                  <c:v>393</c:v>
                </c:pt>
                <c:pt idx="14">
                  <c:v>394</c:v>
                </c:pt>
                <c:pt idx="15">
                  <c:v>395</c:v>
                </c:pt>
                <c:pt idx="16">
                  <c:v>396</c:v>
                </c:pt>
                <c:pt idx="17">
                  <c:v>397</c:v>
                </c:pt>
                <c:pt idx="18">
                  <c:v>398</c:v>
                </c:pt>
                <c:pt idx="19">
                  <c:v>399</c:v>
                </c:pt>
                <c:pt idx="20">
                  <c:v>400</c:v>
                </c:pt>
                <c:pt idx="21">
                  <c:v>401</c:v>
                </c:pt>
                <c:pt idx="22">
                  <c:v>402</c:v>
                </c:pt>
                <c:pt idx="23">
                  <c:v>403</c:v>
                </c:pt>
                <c:pt idx="24">
                  <c:v>404</c:v>
                </c:pt>
                <c:pt idx="25">
                  <c:v>405</c:v>
                </c:pt>
                <c:pt idx="26">
                  <c:v>406</c:v>
                </c:pt>
                <c:pt idx="27">
                  <c:v>407</c:v>
                </c:pt>
                <c:pt idx="28">
                  <c:v>408</c:v>
                </c:pt>
                <c:pt idx="29">
                  <c:v>409</c:v>
                </c:pt>
                <c:pt idx="30">
                  <c:v>410</c:v>
                </c:pt>
                <c:pt idx="31">
                  <c:v>411</c:v>
                </c:pt>
                <c:pt idx="32">
                  <c:v>412</c:v>
                </c:pt>
                <c:pt idx="33">
                  <c:v>413</c:v>
                </c:pt>
                <c:pt idx="34">
                  <c:v>414</c:v>
                </c:pt>
                <c:pt idx="35">
                  <c:v>415</c:v>
                </c:pt>
                <c:pt idx="36">
                  <c:v>416</c:v>
                </c:pt>
                <c:pt idx="37">
                  <c:v>417</c:v>
                </c:pt>
                <c:pt idx="38">
                  <c:v>418</c:v>
                </c:pt>
                <c:pt idx="39">
                  <c:v>419</c:v>
                </c:pt>
                <c:pt idx="40">
                  <c:v>420</c:v>
                </c:pt>
                <c:pt idx="41">
                  <c:v>421</c:v>
                </c:pt>
                <c:pt idx="42">
                  <c:v>422</c:v>
                </c:pt>
                <c:pt idx="43">
                  <c:v>423</c:v>
                </c:pt>
                <c:pt idx="44">
                  <c:v>424</c:v>
                </c:pt>
                <c:pt idx="45">
                  <c:v>425</c:v>
                </c:pt>
                <c:pt idx="46">
                  <c:v>426</c:v>
                </c:pt>
                <c:pt idx="47">
                  <c:v>427</c:v>
                </c:pt>
                <c:pt idx="48">
                  <c:v>428</c:v>
                </c:pt>
                <c:pt idx="49">
                  <c:v>429</c:v>
                </c:pt>
                <c:pt idx="50">
                  <c:v>430</c:v>
                </c:pt>
                <c:pt idx="51">
                  <c:v>431</c:v>
                </c:pt>
                <c:pt idx="52">
                  <c:v>432</c:v>
                </c:pt>
                <c:pt idx="53">
                  <c:v>433</c:v>
                </c:pt>
                <c:pt idx="54">
                  <c:v>434</c:v>
                </c:pt>
                <c:pt idx="55">
                  <c:v>435</c:v>
                </c:pt>
                <c:pt idx="56">
                  <c:v>436</c:v>
                </c:pt>
                <c:pt idx="57">
                  <c:v>437</c:v>
                </c:pt>
                <c:pt idx="58">
                  <c:v>438</c:v>
                </c:pt>
                <c:pt idx="59">
                  <c:v>439</c:v>
                </c:pt>
                <c:pt idx="60">
                  <c:v>440</c:v>
                </c:pt>
                <c:pt idx="61">
                  <c:v>441</c:v>
                </c:pt>
                <c:pt idx="62">
                  <c:v>442</c:v>
                </c:pt>
                <c:pt idx="63">
                  <c:v>443</c:v>
                </c:pt>
                <c:pt idx="64">
                  <c:v>444</c:v>
                </c:pt>
                <c:pt idx="65">
                  <c:v>445</c:v>
                </c:pt>
                <c:pt idx="66">
                  <c:v>446</c:v>
                </c:pt>
                <c:pt idx="67">
                  <c:v>447</c:v>
                </c:pt>
                <c:pt idx="68">
                  <c:v>448</c:v>
                </c:pt>
                <c:pt idx="69">
                  <c:v>449</c:v>
                </c:pt>
                <c:pt idx="70">
                  <c:v>450</c:v>
                </c:pt>
                <c:pt idx="71">
                  <c:v>451</c:v>
                </c:pt>
                <c:pt idx="72">
                  <c:v>452</c:v>
                </c:pt>
                <c:pt idx="73">
                  <c:v>453</c:v>
                </c:pt>
                <c:pt idx="74">
                  <c:v>454</c:v>
                </c:pt>
                <c:pt idx="75">
                  <c:v>455</c:v>
                </c:pt>
                <c:pt idx="76">
                  <c:v>456</c:v>
                </c:pt>
                <c:pt idx="77">
                  <c:v>457</c:v>
                </c:pt>
                <c:pt idx="78">
                  <c:v>458</c:v>
                </c:pt>
                <c:pt idx="79">
                  <c:v>459</c:v>
                </c:pt>
                <c:pt idx="80">
                  <c:v>460</c:v>
                </c:pt>
                <c:pt idx="81">
                  <c:v>461</c:v>
                </c:pt>
                <c:pt idx="82">
                  <c:v>462</c:v>
                </c:pt>
                <c:pt idx="83">
                  <c:v>463</c:v>
                </c:pt>
                <c:pt idx="84">
                  <c:v>464</c:v>
                </c:pt>
                <c:pt idx="85">
                  <c:v>465</c:v>
                </c:pt>
                <c:pt idx="86">
                  <c:v>466</c:v>
                </c:pt>
                <c:pt idx="87">
                  <c:v>467</c:v>
                </c:pt>
                <c:pt idx="88">
                  <c:v>468</c:v>
                </c:pt>
                <c:pt idx="89">
                  <c:v>469</c:v>
                </c:pt>
                <c:pt idx="90">
                  <c:v>470</c:v>
                </c:pt>
                <c:pt idx="91">
                  <c:v>471</c:v>
                </c:pt>
                <c:pt idx="92">
                  <c:v>472</c:v>
                </c:pt>
                <c:pt idx="93">
                  <c:v>473</c:v>
                </c:pt>
                <c:pt idx="94">
                  <c:v>474</c:v>
                </c:pt>
                <c:pt idx="95">
                  <c:v>475</c:v>
                </c:pt>
                <c:pt idx="96">
                  <c:v>476</c:v>
                </c:pt>
                <c:pt idx="97">
                  <c:v>477</c:v>
                </c:pt>
                <c:pt idx="98">
                  <c:v>478</c:v>
                </c:pt>
                <c:pt idx="99">
                  <c:v>479</c:v>
                </c:pt>
                <c:pt idx="100">
                  <c:v>480</c:v>
                </c:pt>
                <c:pt idx="101">
                  <c:v>481</c:v>
                </c:pt>
                <c:pt idx="102">
                  <c:v>482</c:v>
                </c:pt>
                <c:pt idx="103">
                  <c:v>483</c:v>
                </c:pt>
                <c:pt idx="104">
                  <c:v>484</c:v>
                </c:pt>
                <c:pt idx="105">
                  <c:v>485</c:v>
                </c:pt>
                <c:pt idx="106">
                  <c:v>486</c:v>
                </c:pt>
                <c:pt idx="107">
                  <c:v>487</c:v>
                </c:pt>
                <c:pt idx="108">
                  <c:v>488</c:v>
                </c:pt>
                <c:pt idx="109">
                  <c:v>489</c:v>
                </c:pt>
                <c:pt idx="110">
                  <c:v>490</c:v>
                </c:pt>
                <c:pt idx="111">
                  <c:v>491</c:v>
                </c:pt>
                <c:pt idx="112">
                  <c:v>492</c:v>
                </c:pt>
                <c:pt idx="113">
                  <c:v>493</c:v>
                </c:pt>
                <c:pt idx="114">
                  <c:v>494</c:v>
                </c:pt>
                <c:pt idx="115">
                  <c:v>495</c:v>
                </c:pt>
                <c:pt idx="116">
                  <c:v>496</c:v>
                </c:pt>
                <c:pt idx="117">
                  <c:v>497</c:v>
                </c:pt>
                <c:pt idx="118">
                  <c:v>498</c:v>
                </c:pt>
                <c:pt idx="119">
                  <c:v>499</c:v>
                </c:pt>
                <c:pt idx="120">
                  <c:v>500</c:v>
                </c:pt>
                <c:pt idx="121">
                  <c:v>501</c:v>
                </c:pt>
                <c:pt idx="122">
                  <c:v>502</c:v>
                </c:pt>
                <c:pt idx="123">
                  <c:v>503</c:v>
                </c:pt>
                <c:pt idx="124">
                  <c:v>504</c:v>
                </c:pt>
                <c:pt idx="125">
                  <c:v>505</c:v>
                </c:pt>
                <c:pt idx="126">
                  <c:v>506</c:v>
                </c:pt>
                <c:pt idx="127">
                  <c:v>507</c:v>
                </c:pt>
                <c:pt idx="128">
                  <c:v>508</c:v>
                </c:pt>
                <c:pt idx="129">
                  <c:v>509</c:v>
                </c:pt>
                <c:pt idx="130">
                  <c:v>510</c:v>
                </c:pt>
                <c:pt idx="131">
                  <c:v>511</c:v>
                </c:pt>
                <c:pt idx="132">
                  <c:v>512</c:v>
                </c:pt>
                <c:pt idx="133">
                  <c:v>513</c:v>
                </c:pt>
                <c:pt idx="134">
                  <c:v>514</c:v>
                </c:pt>
                <c:pt idx="135">
                  <c:v>515</c:v>
                </c:pt>
                <c:pt idx="136">
                  <c:v>516</c:v>
                </c:pt>
                <c:pt idx="137">
                  <c:v>517</c:v>
                </c:pt>
                <c:pt idx="138">
                  <c:v>518</c:v>
                </c:pt>
                <c:pt idx="139">
                  <c:v>519</c:v>
                </c:pt>
                <c:pt idx="140">
                  <c:v>520</c:v>
                </c:pt>
                <c:pt idx="141">
                  <c:v>521</c:v>
                </c:pt>
                <c:pt idx="142">
                  <c:v>522</c:v>
                </c:pt>
                <c:pt idx="143">
                  <c:v>523</c:v>
                </c:pt>
                <c:pt idx="144">
                  <c:v>524</c:v>
                </c:pt>
                <c:pt idx="145">
                  <c:v>525</c:v>
                </c:pt>
                <c:pt idx="146">
                  <c:v>526</c:v>
                </c:pt>
                <c:pt idx="147">
                  <c:v>527</c:v>
                </c:pt>
                <c:pt idx="148">
                  <c:v>528</c:v>
                </c:pt>
                <c:pt idx="149">
                  <c:v>529</c:v>
                </c:pt>
                <c:pt idx="150">
                  <c:v>530</c:v>
                </c:pt>
                <c:pt idx="151">
                  <c:v>531</c:v>
                </c:pt>
                <c:pt idx="152">
                  <c:v>532</c:v>
                </c:pt>
                <c:pt idx="153">
                  <c:v>533</c:v>
                </c:pt>
                <c:pt idx="154">
                  <c:v>534</c:v>
                </c:pt>
                <c:pt idx="155">
                  <c:v>535</c:v>
                </c:pt>
                <c:pt idx="156">
                  <c:v>536</c:v>
                </c:pt>
                <c:pt idx="157">
                  <c:v>537</c:v>
                </c:pt>
                <c:pt idx="158">
                  <c:v>538</c:v>
                </c:pt>
                <c:pt idx="159">
                  <c:v>539</c:v>
                </c:pt>
                <c:pt idx="160">
                  <c:v>540</c:v>
                </c:pt>
                <c:pt idx="161">
                  <c:v>541</c:v>
                </c:pt>
                <c:pt idx="162">
                  <c:v>542</c:v>
                </c:pt>
                <c:pt idx="163">
                  <c:v>543</c:v>
                </c:pt>
                <c:pt idx="164">
                  <c:v>544</c:v>
                </c:pt>
                <c:pt idx="165">
                  <c:v>545</c:v>
                </c:pt>
                <c:pt idx="166">
                  <c:v>546</c:v>
                </c:pt>
                <c:pt idx="167">
                  <c:v>547</c:v>
                </c:pt>
                <c:pt idx="168">
                  <c:v>548</c:v>
                </c:pt>
                <c:pt idx="169">
                  <c:v>549</c:v>
                </c:pt>
                <c:pt idx="170">
                  <c:v>550</c:v>
                </c:pt>
                <c:pt idx="171">
                  <c:v>551</c:v>
                </c:pt>
                <c:pt idx="172">
                  <c:v>552</c:v>
                </c:pt>
                <c:pt idx="173">
                  <c:v>553</c:v>
                </c:pt>
                <c:pt idx="174">
                  <c:v>554</c:v>
                </c:pt>
                <c:pt idx="175">
                  <c:v>555</c:v>
                </c:pt>
                <c:pt idx="176">
                  <c:v>556</c:v>
                </c:pt>
                <c:pt idx="177">
                  <c:v>557</c:v>
                </c:pt>
                <c:pt idx="178">
                  <c:v>558</c:v>
                </c:pt>
                <c:pt idx="179">
                  <c:v>559</c:v>
                </c:pt>
                <c:pt idx="180">
                  <c:v>560</c:v>
                </c:pt>
                <c:pt idx="181">
                  <c:v>561</c:v>
                </c:pt>
                <c:pt idx="182">
                  <c:v>562</c:v>
                </c:pt>
                <c:pt idx="183">
                  <c:v>563</c:v>
                </c:pt>
                <c:pt idx="184">
                  <c:v>564</c:v>
                </c:pt>
                <c:pt idx="185">
                  <c:v>565</c:v>
                </c:pt>
                <c:pt idx="186">
                  <c:v>566</c:v>
                </c:pt>
                <c:pt idx="187">
                  <c:v>567</c:v>
                </c:pt>
                <c:pt idx="188">
                  <c:v>568</c:v>
                </c:pt>
                <c:pt idx="189">
                  <c:v>569</c:v>
                </c:pt>
                <c:pt idx="190">
                  <c:v>570</c:v>
                </c:pt>
                <c:pt idx="191">
                  <c:v>571</c:v>
                </c:pt>
                <c:pt idx="192">
                  <c:v>572</c:v>
                </c:pt>
                <c:pt idx="193">
                  <c:v>573</c:v>
                </c:pt>
                <c:pt idx="194">
                  <c:v>574</c:v>
                </c:pt>
                <c:pt idx="195">
                  <c:v>575</c:v>
                </c:pt>
                <c:pt idx="196">
                  <c:v>576</c:v>
                </c:pt>
                <c:pt idx="197">
                  <c:v>577</c:v>
                </c:pt>
                <c:pt idx="198">
                  <c:v>578</c:v>
                </c:pt>
                <c:pt idx="199">
                  <c:v>579</c:v>
                </c:pt>
                <c:pt idx="200">
                  <c:v>580</c:v>
                </c:pt>
                <c:pt idx="201">
                  <c:v>581</c:v>
                </c:pt>
                <c:pt idx="202">
                  <c:v>582</c:v>
                </c:pt>
                <c:pt idx="203">
                  <c:v>583</c:v>
                </c:pt>
                <c:pt idx="204">
                  <c:v>584</c:v>
                </c:pt>
                <c:pt idx="205">
                  <c:v>585</c:v>
                </c:pt>
                <c:pt idx="206">
                  <c:v>586</c:v>
                </c:pt>
                <c:pt idx="207">
                  <c:v>587</c:v>
                </c:pt>
                <c:pt idx="208">
                  <c:v>588</c:v>
                </c:pt>
                <c:pt idx="209">
                  <c:v>589</c:v>
                </c:pt>
                <c:pt idx="210">
                  <c:v>590</c:v>
                </c:pt>
                <c:pt idx="211">
                  <c:v>591</c:v>
                </c:pt>
                <c:pt idx="212">
                  <c:v>592</c:v>
                </c:pt>
                <c:pt idx="213">
                  <c:v>593</c:v>
                </c:pt>
                <c:pt idx="214">
                  <c:v>594</c:v>
                </c:pt>
                <c:pt idx="215">
                  <c:v>595</c:v>
                </c:pt>
                <c:pt idx="216">
                  <c:v>596</c:v>
                </c:pt>
                <c:pt idx="217">
                  <c:v>597</c:v>
                </c:pt>
                <c:pt idx="218">
                  <c:v>598</c:v>
                </c:pt>
                <c:pt idx="219">
                  <c:v>599</c:v>
                </c:pt>
                <c:pt idx="220">
                  <c:v>600</c:v>
                </c:pt>
                <c:pt idx="221">
                  <c:v>601</c:v>
                </c:pt>
                <c:pt idx="222">
                  <c:v>602</c:v>
                </c:pt>
                <c:pt idx="223">
                  <c:v>603</c:v>
                </c:pt>
                <c:pt idx="224">
                  <c:v>604</c:v>
                </c:pt>
                <c:pt idx="225">
                  <c:v>605</c:v>
                </c:pt>
                <c:pt idx="226">
                  <c:v>606</c:v>
                </c:pt>
                <c:pt idx="227">
                  <c:v>607</c:v>
                </c:pt>
                <c:pt idx="228">
                  <c:v>608</c:v>
                </c:pt>
                <c:pt idx="229">
                  <c:v>609</c:v>
                </c:pt>
                <c:pt idx="230">
                  <c:v>610</c:v>
                </c:pt>
                <c:pt idx="231">
                  <c:v>611</c:v>
                </c:pt>
                <c:pt idx="232">
                  <c:v>612</c:v>
                </c:pt>
                <c:pt idx="233">
                  <c:v>613</c:v>
                </c:pt>
                <c:pt idx="234">
                  <c:v>614</c:v>
                </c:pt>
                <c:pt idx="235">
                  <c:v>615</c:v>
                </c:pt>
                <c:pt idx="236">
                  <c:v>616</c:v>
                </c:pt>
                <c:pt idx="237">
                  <c:v>617</c:v>
                </c:pt>
                <c:pt idx="238">
                  <c:v>618</c:v>
                </c:pt>
                <c:pt idx="239">
                  <c:v>619</c:v>
                </c:pt>
                <c:pt idx="240">
                  <c:v>620</c:v>
                </c:pt>
                <c:pt idx="241">
                  <c:v>621</c:v>
                </c:pt>
                <c:pt idx="242">
                  <c:v>622</c:v>
                </c:pt>
                <c:pt idx="243">
                  <c:v>623</c:v>
                </c:pt>
                <c:pt idx="244">
                  <c:v>624</c:v>
                </c:pt>
                <c:pt idx="245">
                  <c:v>625</c:v>
                </c:pt>
                <c:pt idx="246">
                  <c:v>626</c:v>
                </c:pt>
                <c:pt idx="247">
                  <c:v>627</c:v>
                </c:pt>
                <c:pt idx="248">
                  <c:v>628</c:v>
                </c:pt>
                <c:pt idx="249">
                  <c:v>629</c:v>
                </c:pt>
                <c:pt idx="250">
                  <c:v>630</c:v>
                </c:pt>
                <c:pt idx="251">
                  <c:v>631</c:v>
                </c:pt>
                <c:pt idx="252">
                  <c:v>632</c:v>
                </c:pt>
                <c:pt idx="253">
                  <c:v>633</c:v>
                </c:pt>
                <c:pt idx="254">
                  <c:v>634</c:v>
                </c:pt>
                <c:pt idx="255">
                  <c:v>635</c:v>
                </c:pt>
                <c:pt idx="256">
                  <c:v>636</c:v>
                </c:pt>
                <c:pt idx="257">
                  <c:v>637</c:v>
                </c:pt>
                <c:pt idx="258">
                  <c:v>638</c:v>
                </c:pt>
                <c:pt idx="259">
                  <c:v>639</c:v>
                </c:pt>
                <c:pt idx="260">
                  <c:v>640</c:v>
                </c:pt>
                <c:pt idx="261">
                  <c:v>641</c:v>
                </c:pt>
                <c:pt idx="262">
                  <c:v>642</c:v>
                </c:pt>
                <c:pt idx="263">
                  <c:v>643</c:v>
                </c:pt>
                <c:pt idx="264">
                  <c:v>644</c:v>
                </c:pt>
                <c:pt idx="265">
                  <c:v>645</c:v>
                </c:pt>
                <c:pt idx="266">
                  <c:v>646</c:v>
                </c:pt>
                <c:pt idx="267">
                  <c:v>647</c:v>
                </c:pt>
                <c:pt idx="268">
                  <c:v>648</c:v>
                </c:pt>
                <c:pt idx="269">
                  <c:v>649</c:v>
                </c:pt>
                <c:pt idx="270">
                  <c:v>650</c:v>
                </c:pt>
                <c:pt idx="271">
                  <c:v>651</c:v>
                </c:pt>
                <c:pt idx="272">
                  <c:v>652</c:v>
                </c:pt>
                <c:pt idx="273">
                  <c:v>653</c:v>
                </c:pt>
                <c:pt idx="274">
                  <c:v>654</c:v>
                </c:pt>
                <c:pt idx="275">
                  <c:v>655</c:v>
                </c:pt>
                <c:pt idx="276">
                  <c:v>656</c:v>
                </c:pt>
                <c:pt idx="277">
                  <c:v>657</c:v>
                </c:pt>
                <c:pt idx="278">
                  <c:v>658</c:v>
                </c:pt>
                <c:pt idx="279">
                  <c:v>659</c:v>
                </c:pt>
                <c:pt idx="280">
                  <c:v>660</c:v>
                </c:pt>
                <c:pt idx="281">
                  <c:v>661</c:v>
                </c:pt>
                <c:pt idx="282">
                  <c:v>662</c:v>
                </c:pt>
                <c:pt idx="283">
                  <c:v>663</c:v>
                </c:pt>
                <c:pt idx="284">
                  <c:v>664</c:v>
                </c:pt>
                <c:pt idx="285">
                  <c:v>665</c:v>
                </c:pt>
                <c:pt idx="286">
                  <c:v>666</c:v>
                </c:pt>
                <c:pt idx="287">
                  <c:v>667</c:v>
                </c:pt>
                <c:pt idx="288">
                  <c:v>668</c:v>
                </c:pt>
                <c:pt idx="289">
                  <c:v>669</c:v>
                </c:pt>
                <c:pt idx="290">
                  <c:v>670</c:v>
                </c:pt>
                <c:pt idx="291">
                  <c:v>671</c:v>
                </c:pt>
                <c:pt idx="292">
                  <c:v>672</c:v>
                </c:pt>
                <c:pt idx="293">
                  <c:v>673</c:v>
                </c:pt>
                <c:pt idx="294">
                  <c:v>674</c:v>
                </c:pt>
                <c:pt idx="295">
                  <c:v>675</c:v>
                </c:pt>
                <c:pt idx="296">
                  <c:v>676</c:v>
                </c:pt>
                <c:pt idx="297">
                  <c:v>677</c:v>
                </c:pt>
                <c:pt idx="298">
                  <c:v>678</c:v>
                </c:pt>
                <c:pt idx="299">
                  <c:v>679</c:v>
                </c:pt>
                <c:pt idx="300">
                  <c:v>680</c:v>
                </c:pt>
                <c:pt idx="301">
                  <c:v>681</c:v>
                </c:pt>
                <c:pt idx="302">
                  <c:v>682</c:v>
                </c:pt>
                <c:pt idx="303">
                  <c:v>683</c:v>
                </c:pt>
                <c:pt idx="304">
                  <c:v>684</c:v>
                </c:pt>
                <c:pt idx="305">
                  <c:v>685</c:v>
                </c:pt>
                <c:pt idx="306">
                  <c:v>686</c:v>
                </c:pt>
                <c:pt idx="307">
                  <c:v>687</c:v>
                </c:pt>
                <c:pt idx="308">
                  <c:v>688</c:v>
                </c:pt>
                <c:pt idx="309">
                  <c:v>689</c:v>
                </c:pt>
                <c:pt idx="310">
                  <c:v>690</c:v>
                </c:pt>
                <c:pt idx="311">
                  <c:v>691</c:v>
                </c:pt>
                <c:pt idx="312">
                  <c:v>692</c:v>
                </c:pt>
                <c:pt idx="313">
                  <c:v>693</c:v>
                </c:pt>
                <c:pt idx="314">
                  <c:v>694</c:v>
                </c:pt>
                <c:pt idx="315">
                  <c:v>695</c:v>
                </c:pt>
                <c:pt idx="316">
                  <c:v>696</c:v>
                </c:pt>
                <c:pt idx="317">
                  <c:v>697</c:v>
                </c:pt>
                <c:pt idx="318">
                  <c:v>698</c:v>
                </c:pt>
                <c:pt idx="319">
                  <c:v>699</c:v>
                </c:pt>
                <c:pt idx="320">
                  <c:v>700</c:v>
                </c:pt>
                <c:pt idx="321">
                  <c:v>701</c:v>
                </c:pt>
                <c:pt idx="322">
                  <c:v>702</c:v>
                </c:pt>
                <c:pt idx="323">
                  <c:v>703</c:v>
                </c:pt>
                <c:pt idx="324">
                  <c:v>704</c:v>
                </c:pt>
                <c:pt idx="325">
                  <c:v>705</c:v>
                </c:pt>
                <c:pt idx="326">
                  <c:v>706</c:v>
                </c:pt>
                <c:pt idx="327">
                  <c:v>707</c:v>
                </c:pt>
                <c:pt idx="328">
                  <c:v>708</c:v>
                </c:pt>
                <c:pt idx="329">
                  <c:v>709</c:v>
                </c:pt>
                <c:pt idx="330">
                  <c:v>710</c:v>
                </c:pt>
                <c:pt idx="331">
                  <c:v>711</c:v>
                </c:pt>
                <c:pt idx="332">
                  <c:v>712</c:v>
                </c:pt>
                <c:pt idx="333">
                  <c:v>713</c:v>
                </c:pt>
                <c:pt idx="334">
                  <c:v>714</c:v>
                </c:pt>
                <c:pt idx="335">
                  <c:v>715</c:v>
                </c:pt>
                <c:pt idx="336">
                  <c:v>716</c:v>
                </c:pt>
                <c:pt idx="337">
                  <c:v>717</c:v>
                </c:pt>
                <c:pt idx="338">
                  <c:v>718</c:v>
                </c:pt>
                <c:pt idx="339">
                  <c:v>719</c:v>
                </c:pt>
                <c:pt idx="340">
                  <c:v>720</c:v>
                </c:pt>
                <c:pt idx="341">
                  <c:v>721</c:v>
                </c:pt>
                <c:pt idx="342">
                  <c:v>722</c:v>
                </c:pt>
                <c:pt idx="343">
                  <c:v>723</c:v>
                </c:pt>
                <c:pt idx="344">
                  <c:v>724</c:v>
                </c:pt>
                <c:pt idx="345">
                  <c:v>725</c:v>
                </c:pt>
                <c:pt idx="346">
                  <c:v>726</c:v>
                </c:pt>
                <c:pt idx="347">
                  <c:v>727</c:v>
                </c:pt>
                <c:pt idx="348">
                  <c:v>728</c:v>
                </c:pt>
                <c:pt idx="349">
                  <c:v>729</c:v>
                </c:pt>
                <c:pt idx="350">
                  <c:v>730</c:v>
                </c:pt>
                <c:pt idx="351">
                  <c:v>731</c:v>
                </c:pt>
                <c:pt idx="352">
                  <c:v>732</c:v>
                </c:pt>
                <c:pt idx="353">
                  <c:v>733</c:v>
                </c:pt>
                <c:pt idx="354">
                  <c:v>734</c:v>
                </c:pt>
                <c:pt idx="355">
                  <c:v>735</c:v>
                </c:pt>
                <c:pt idx="356">
                  <c:v>736</c:v>
                </c:pt>
                <c:pt idx="357">
                  <c:v>737</c:v>
                </c:pt>
                <c:pt idx="358">
                  <c:v>738</c:v>
                </c:pt>
                <c:pt idx="359">
                  <c:v>739</c:v>
                </c:pt>
                <c:pt idx="360">
                  <c:v>740</c:v>
                </c:pt>
                <c:pt idx="361">
                  <c:v>741</c:v>
                </c:pt>
                <c:pt idx="362">
                  <c:v>742</c:v>
                </c:pt>
                <c:pt idx="363">
                  <c:v>743</c:v>
                </c:pt>
                <c:pt idx="364">
                  <c:v>744</c:v>
                </c:pt>
                <c:pt idx="365">
                  <c:v>745</c:v>
                </c:pt>
                <c:pt idx="366">
                  <c:v>746</c:v>
                </c:pt>
                <c:pt idx="367">
                  <c:v>747</c:v>
                </c:pt>
                <c:pt idx="368">
                  <c:v>748</c:v>
                </c:pt>
                <c:pt idx="369">
                  <c:v>749</c:v>
                </c:pt>
                <c:pt idx="370">
                  <c:v>750</c:v>
                </c:pt>
                <c:pt idx="371">
                  <c:v>751</c:v>
                </c:pt>
                <c:pt idx="372">
                  <c:v>752</c:v>
                </c:pt>
                <c:pt idx="373">
                  <c:v>753</c:v>
                </c:pt>
                <c:pt idx="374">
                  <c:v>754</c:v>
                </c:pt>
                <c:pt idx="375">
                  <c:v>755</c:v>
                </c:pt>
                <c:pt idx="376">
                  <c:v>756</c:v>
                </c:pt>
                <c:pt idx="377">
                  <c:v>757</c:v>
                </c:pt>
                <c:pt idx="378">
                  <c:v>758</c:v>
                </c:pt>
                <c:pt idx="379">
                  <c:v>759</c:v>
                </c:pt>
                <c:pt idx="380">
                  <c:v>760</c:v>
                </c:pt>
                <c:pt idx="381">
                  <c:v>761</c:v>
                </c:pt>
                <c:pt idx="382">
                  <c:v>762</c:v>
                </c:pt>
                <c:pt idx="383">
                  <c:v>763</c:v>
                </c:pt>
                <c:pt idx="384">
                  <c:v>764</c:v>
                </c:pt>
                <c:pt idx="385">
                  <c:v>765</c:v>
                </c:pt>
                <c:pt idx="386">
                  <c:v>766</c:v>
                </c:pt>
                <c:pt idx="387">
                  <c:v>767</c:v>
                </c:pt>
                <c:pt idx="388">
                  <c:v>768</c:v>
                </c:pt>
                <c:pt idx="389">
                  <c:v>769</c:v>
                </c:pt>
                <c:pt idx="390">
                  <c:v>770</c:v>
                </c:pt>
                <c:pt idx="391">
                  <c:v>771</c:v>
                </c:pt>
                <c:pt idx="392">
                  <c:v>772</c:v>
                </c:pt>
                <c:pt idx="393">
                  <c:v>773</c:v>
                </c:pt>
                <c:pt idx="394">
                  <c:v>774</c:v>
                </c:pt>
                <c:pt idx="395">
                  <c:v>775</c:v>
                </c:pt>
                <c:pt idx="396">
                  <c:v>776</c:v>
                </c:pt>
                <c:pt idx="397">
                  <c:v>777</c:v>
                </c:pt>
                <c:pt idx="398">
                  <c:v>778</c:v>
                </c:pt>
                <c:pt idx="399">
                  <c:v>779</c:v>
                </c:pt>
                <c:pt idx="400">
                  <c:v>780</c:v>
                </c:pt>
              </c:numCache>
            </c:numRef>
          </c:cat>
          <c:val>
            <c:numRef>
              <c:f>'Irradiancia Algameca'!$B$68:$B$468</c:f>
              <c:numCache>
                <c:formatCode>General</c:formatCode>
                <c:ptCount val="401"/>
                <c:pt idx="0">
                  <c:v>6.326E-3</c:v>
                </c:pt>
                <c:pt idx="1">
                  <c:v>1.567E-3</c:v>
                </c:pt>
                <c:pt idx="2">
                  <c:v>6.8499999999999995E-4</c:v>
                </c:pt>
                <c:pt idx="3">
                  <c:v>1.289E-3</c:v>
                </c:pt>
                <c:pt idx="4">
                  <c:v>1.6819999999999999E-3</c:v>
                </c:pt>
                <c:pt idx="5">
                  <c:v>1.691E-3</c:v>
                </c:pt>
                <c:pt idx="6">
                  <c:v>7.1199999999999996E-4</c:v>
                </c:pt>
                <c:pt idx="7">
                  <c:v>3.8900000000000002E-4</c:v>
                </c:pt>
                <c:pt idx="8">
                  <c:v>2.0760000000000002E-3</c:v>
                </c:pt>
                <c:pt idx="9">
                  <c:v>4.2719999999999998E-3</c:v>
                </c:pt>
                <c:pt idx="10">
                  <c:v>4.4180000000000001E-3</c:v>
                </c:pt>
                <c:pt idx="11">
                  <c:v>3.5869999999999999E-3</c:v>
                </c:pt>
                <c:pt idx="12">
                  <c:v>1.7060000000000001E-3</c:v>
                </c:pt>
                <c:pt idx="13">
                  <c:v>2.9009999999999999E-3</c:v>
                </c:pt>
                <c:pt idx="14">
                  <c:v>1.0078E-2</c:v>
                </c:pt>
                <c:pt idx="15">
                  <c:v>1.5294E-2</c:v>
                </c:pt>
                <c:pt idx="16">
                  <c:v>1.6580000000000001E-2</c:v>
                </c:pt>
                <c:pt idx="17">
                  <c:v>1.4411999999999999E-2</c:v>
                </c:pt>
                <c:pt idx="18">
                  <c:v>1.3528999999999999E-2</c:v>
                </c:pt>
                <c:pt idx="19">
                  <c:v>1.6160999999999998E-2</c:v>
                </c:pt>
                <c:pt idx="20">
                  <c:v>2.0069E-2</c:v>
                </c:pt>
                <c:pt idx="21">
                  <c:v>2.1826000000000002E-2</c:v>
                </c:pt>
                <c:pt idx="22">
                  <c:v>2.3446999999999999E-2</c:v>
                </c:pt>
                <c:pt idx="23">
                  <c:v>2.5409000000000001E-2</c:v>
                </c:pt>
                <c:pt idx="24">
                  <c:v>2.7130000000000001E-2</c:v>
                </c:pt>
                <c:pt idx="25">
                  <c:v>2.6402999999999999E-2</c:v>
                </c:pt>
                <c:pt idx="26">
                  <c:v>2.4857000000000001E-2</c:v>
                </c:pt>
                <c:pt idx="27">
                  <c:v>2.6741999999999998E-2</c:v>
                </c:pt>
                <c:pt idx="28">
                  <c:v>2.8728E-2</c:v>
                </c:pt>
                <c:pt idx="29">
                  <c:v>3.7828000000000001E-2</c:v>
                </c:pt>
                <c:pt idx="30">
                  <c:v>4.3583999999999998E-2</c:v>
                </c:pt>
                <c:pt idx="31">
                  <c:v>5.2044E-2</c:v>
                </c:pt>
                <c:pt idx="32">
                  <c:v>5.7263000000000001E-2</c:v>
                </c:pt>
                <c:pt idx="33">
                  <c:v>6.5437999999999996E-2</c:v>
                </c:pt>
                <c:pt idx="34">
                  <c:v>7.2588E-2</c:v>
                </c:pt>
                <c:pt idx="35">
                  <c:v>8.1651000000000001E-2</c:v>
                </c:pt>
                <c:pt idx="36">
                  <c:v>9.5467999999999997E-2</c:v>
                </c:pt>
                <c:pt idx="37">
                  <c:v>0.108463</c:v>
                </c:pt>
                <c:pt idx="38">
                  <c:v>0.12782499999999999</c:v>
                </c:pt>
                <c:pt idx="39">
                  <c:v>0.14565600000000001</c:v>
                </c:pt>
                <c:pt idx="40">
                  <c:v>0.16931199999999999</c:v>
                </c:pt>
                <c:pt idx="41">
                  <c:v>0.19986400000000001</c:v>
                </c:pt>
                <c:pt idx="42">
                  <c:v>0.237592</c:v>
                </c:pt>
                <c:pt idx="43">
                  <c:v>0.282358</c:v>
                </c:pt>
                <c:pt idx="44">
                  <c:v>0.33043299999999998</c:v>
                </c:pt>
                <c:pt idx="45">
                  <c:v>0.38325700000000001</c:v>
                </c:pt>
                <c:pt idx="46">
                  <c:v>0.44059300000000001</c:v>
                </c:pt>
                <c:pt idx="47">
                  <c:v>0.50865300000000002</c:v>
                </c:pt>
                <c:pt idx="48">
                  <c:v>0.585816</c:v>
                </c:pt>
                <c:pt idx="49">
                  <c:v>0.67142000000000002</c:v>
                </c:pt>
                <c:pt idx="50">
                  <c:v>0.77148600000000001</c:v>
                </c:pt>
                <c:pt idx="51">
                  <c:v>0.88003799999999999</c:v>
                </c:pt>
                <c:pt idx="52">
                  <c:v>1.0024169999999999</c:v>
                </c:pt>
                <c:pt idx="53">
                  <c:v>1.133947</c:v>
                </c:pt>
                <c:pt idx="54">
                  <c:v>1.2787379999999999</c:v>
                </c:pt>
                <c:pt idx="55">
                  <c:v>1.4404889999999999</c:v>
                </c:pt>
                <c:pt idx="56">
                  <c:v>1.600533</c:v>
                </c:pt>
                <c:pt idx="57">
                  <c:v>1.7974939999999999</c:v>
                </c:pt>
                <c:pt idx="58">
                  <c:v>2.0090780000000001</c:v>
                </c:pt>
                <c:pt idx="59">
                  <c:v>2.2472829999999999</c:v>
                </c:pt>
                <c:pt idx="60">
                  <c:v>2.5041769999999999</c:v>
                </c:pt>
                <c:pt idx="61">
                  <c:v>2.7799680000000002</c:v>
                </c:pt>
                <c:pt idx="62">
                  <c:v>3.0753439999999999</c:v>
                </c:pt>
                <c:pt idx="63">
                  <c:v>3.3737910000000002</c:v>
                </c:pt>
                <c:pt idx="64">
                  <c:v>3.6769699999999998</c:v>
                </c:pt>
                <c:pt idx="65">
                  <c:v>3.9447869999999998</c:v>
                </c:pt>
                <c:pt idx="66">
                  <c:v>4.1486679999999998</c:v>
                </c:pt>
                <c:pt idx="67">
                  <c:v>4.2584499999999998</c:v>
                </c:pt>
                <c:pt idx="68">
                  <c:v>4.2673719999999999</c:v>
                </c:pt>
                <c:pt idx="69">
                  <c:v>4.1843500000000002</c:v>
                </c:pt>
                <c:pt idx="70">
                  <c:v>4.0293869999999998</c:v>
                </c:pt>
                <c:pt idx="71">
                  <c:v>3.8408540000000002</c:v>
                </c:pt>
                <c:pt idx="72">
                  <c:v>3.6166640000000001</c:v>
                </c:pt>
                <c:pt idx="73">
                  <c:v>3.3749980000000002</c:v>
                </c:pt>
                <c:pt idx="74">
                  <c:v>3.110827</c:v>
                </c:pt>
                <c:pt idx="75">
                  <c:v>2.8478699999999999</c:v>
                </c:pt>
                <c:pt idx="76">
                  <c:v>2.6056400000000002</c:v>
                </c:pt>
                <c:pt idx="77">
                  <c:v>2.397357</c:v>
                </c:pt>
                <c:pt idx="78">
                  <c:v>2.2224740000000001</c:v>
                </c:pt>
                <c:pt idx="79">
                  <c:v>2.0814140000000001</c:v>
                </c:pt>
                <c:pt idx="80">
                  <c:v>1.9605049999999999</c:v>
                </c:pt>
                <c:pt idx="81">
                  <c:v>1.8526020000000001</c:v>
                </c:pt>
                <c:pt idx="82">
                  <c:v>1.7492559999999999</c:v>
                </c:pt>
                <c:pt idx="83">
                  <c:v>1.6466940000000001</c:v>
                </c:pt>
                <c:pt idx="84">
                  <c:v>1.5446029999999999</c:v>
                </c:pt>
                <c:pt idx="85">
                  <c:v>1.443163</c:v>
                </c:pt>
                <c:pt idx="86">
                  <c:v>1.3436429999999999</c:v>
                </c:pt>
                <c:pt idx="87">
                  <c:v>1.247757</c:v>
                </c:pt>
                <c:pt idx="88">
                  <c:v>1.1582110000000001</c:v>
                </c:pt>
                <c:pt idx="89">
                  <c:v>1.0847629999999999</c:v>
                </c:pt>
                <c:pt idx="90">
                  <c:v>1.0069459999999999</c:v>
                </c:pt>
                <c:pt idx="91">
                  <c:v>0.93905700000000003</c:v>
                </c:pt>
                <c:pt idx="92">
                  <c:v>0.88038099999999997</c:v>
                </c:pt>
                <c:pt idx="93">
                  <c:v>0.83227399999999996</c:v>
                </c:pt>
                <c:pt idx="94">
                  <c:v>0.79919499999999999</c:v>
                </c:pt>
                <c:pt idx="95">
                  <c:v>0.77728699999999995</c:v>
                </c:pt>
                <c:pt idx="96">
                  <c:v>0.76675599999999999</c:v>
                </c:pt>
                <c:pt idx="97">
                  <c:v>0.76271100000000003</c:v>
                </c:pt>
                <c:pt idx="98">
                  <c:v>0.75954900000000003</c:v>
                </c:pt>
                <c:pt idx="99">
                  <c:v>0.75948199999999999</c:v>
                </c:pt>
                <c:pt idx="100">
                  <c:v>0.75876399999999999</c:v>
                </c:pt>
                <c:pt idx="101">
                  <c:v>0.75982700000000003</c:v>
                </c:pt>
                <c:pt idx="102">
                  <c:v>0.76731300000000002</c:v>
                </c:pt>
                <c:pt idx="103">
                  <c:v>0.77851599999999999</c:v>
                </c:pt>
                <c:pt idx="104">
                  <c:v>0.79815999999999998</c:v>
                </c:pt>
                <c:pt idx="105">
                  <c:v>0.82228800000000002</c:v>
                </c:pt>
                <c:pt idx="106">
                  <c:v>0.85457700000000003</c:v>
                </c:pt>
                <c:pt idx="107">
                  <c:v>0.88941000000000003</c:v>
                </c:pt>
                <c:pt idx="108">
                  <c:v>0.92869800000000002</c:v>
                </c:pt>
                <c:pt idx="109">
                  <c:v>0.96839799999999998</c:v>
                </c:pt>
                <c:pt idx="110">
                  <c:v>1.0102850000000001</c:v>
                </c:pt>
                <c:pt idx="111">
                  <c:v>1.0576399999999999</c:v>
                </c:pt>
                <c:pt idx="112">
                  <c:v>1.1061350000000001</c:v>
                </c:pt>
                <c:pt idx="113">
                  <c:v>1.1570009999999999</c:v>
                </c:pt>
                <c:pt idx="114">
                  <c:v>1.2145840000000001</c:v>
                </c:pt>
                <c:pt idx="115">
                  <c:v>1.2720629999999999</c:v>
                </c:pt>
                <c:pt idx="116">
                  <c:v>1.329537</c:v>
                </c:pt>
                <c:pt idx="117">
                  <c:v>1.381413</c:v>
                </c:pt>
                <c:pt idx="118">
                  <c:v>1.4367669999999999</c:v>
                </c:pt>
                <c:pt idx="119">
                  <c:v>1.4952049999999999</c:v>
                </c:pt>
                <c:pt idx="120">
                  <c:v>1.551437</c:v>
                </c:pt>
                <c:pt idx="121">
                  <c:v>1.6083430000000001</c:v>
                </c:pt>
                <c:pt idx="122">
                  <c:v>1.6647289999999999</c:v>
                </c:pt>
                <c:pt idx="123">
                  <c:v>1.7240549999999999</c:v>
                </c:pt>
                <c:pt idx="124">
                  <c:v>1.77948</c:v>
                </c:pt>
                <c:pt idx="125">
                  <c:v>1.8293729999999999</c:v>
                </c:pt>
                <c:pt idx="126">
                  <c:v>1.8792819999999999</c:v>
                </c:pt>
                <c:pt idx="127">
                  <c:v>1.9260360000000001</c:v>
                </c:pt>
                <c:pt idx="128">
                  <c:v>1.9751300000000001</c:v>
                </c:pt>
                <c:pt idx="129">
                  <c:v>2.021398</c:v>
                </c:pt>
                <c:pt idx="130">
                  <c:v>2.0608430000000002</c:v>
                </c:pt>
                <c:pt idx="131">
                  <c:v>2.0992060000000001</c:v>
                </c:pt>
                <c:pt idx="132">
                  <c:v>2.1339600000000001</c:v>
                </c:pt>
                <c:pt idx="133">
                  <c:v>2.164463</c:v>
                </c:pt>
                <c:pt idx="134">
                  <c:v>2.199001</c:v>
                </c:pt>
                <c:pt idx="135">
                  <c:v>2.2280190000000002</c:v>
                </c:pt>
                <c:pt idx="136">
                  <c:v>2.2594889999999999</c:v>
                </c:pt>
                <c:pt idx="137">
                  <c:v>2.285974</c:v>
                </c:pt>
                <c:pt idx="138">
                  <c:v>2.3107920000000002</c:v>
                </c:pt>
                <c:pt idx="139">
                  <c:v>2.3326609999999999</c:v>
                </c:pt>
                <c:pt idx="140">
                  <c:v>2.3535840000000001</c:v>
                </c:pt>
                <c:pt idx="141">
                  <c:v>2.3738700000000001</c:v>
                </c:pt>
                <c:pt idx="142">
                  <c:v>2.3946710000000002</c:v>
                </c:pt>
                <c:pt idx="143">
                  <c:v>2.4162949999999999</c:v>
                </c:pt>
                <c:pt idx="144">
                  <c:v>2.4324180000000002</c:v>
                </c:pt>
                <c:pt idx="145">
                  <c:v>2.452728</c:v>
                </c:pt>
                <c:pt idx="146">
                  <c:v>2.469732</c:v>
                </c:pt>
                <c:pt idx="147">
                  <c:v>2.4865569999999999</c:v>
                </c:pt>
                <c:pt idx="148">
                  <c:v>2.4993470000000002</c:v>
                </c:pt>
                <c:pt idx="149">
                  <c:v>2.513385</c:v>
                </c:pt>
                <c:pt idx="150">
                  <c:v>2.530872</c:v>
                </c:pt>
                <c:pt idx="151">
                  <c:v>2.547828</c:v>
                </c:pt>
                <c:pt idx="152">
                  <c:v>2.5624989999999999</c:v>
                </c:pt>
                <c:pt idx="153">
                  <c:v>2.5772040000000001</c:v>
                </c:pt>
                <c:pt idx="154">
                  <c:v>2.592365</c:v>
                </c:pt>
                <c:pt idx="155">
                  <c:v>2.6071719999999998</c:v>
                </c:pt>
                <c:pt idx="156">
                  <c:v>2.620574</c:v>
                </c:pt>
                <c:pt idx="157">
                  <c:v>2.6331129999999998</c:v>
                </c:pt>
                <c:pt idx="158">
                  <c:v>2.644593</c:v>
                </c:pt>
                <c:pt idx="159">
                  <c:v>2.6622140000000001</c:v>
                </c:pt>
                <c:pt idx="160">
                  <c:v>2.6779489999999999</c:v>
                </c:pt>
                <c:pt idx="161">
                  <c:v>2.695506</c:v>
                </c:pt>
                <c:pt idx="162">
                  <c:v>2.7100490000000002</c:v>
                </c:pt>
                <c:pt idx="163">
                  <c:v>2.7216469999999999</c:v>
                </c:pt>
                <c:pt idx="164">
                  <c:v>2.7320570000000002</c:v>
                </c:pt>
                <c:pt idx="165">
                  <c:v>2.7419889999999998</c:v>
                </c:pt>
                <c:pt idx="166">
                  <c:v>2.7506569999999999</c:v>
                </c:pt>
                <c:pt idx="167">
                  <c:v>2.7608950000000001</c:v>
                </c:pt>
                <c:pt idx="168">
                  <c:v>2.7701500000000001</c:v>
                </c:pt>
                <c:pt idx="169">
                  <c:v>2.779792</c:v>
                </c:pt>
                <c:pt idx="170">
                  <c:v>2.788732</c:v>
                </c:pt>
                <c:pt idx="171">
                  <c:v>2.8023539999999998</c:v>
                </c:pt>
                <c:pt idx="172">
                  <c:v>2.817256</c:v>
                </c:pt>
                <c:pt idx="173">
                  <c:v>2.8350840000000002</c:v>
                </c:pt>
                <c:pt idx="174">
                  <c:v>2.8512140000000001</c:v>
                </c:pt>
                <c:pt idx="175">
                  <c:v>2.86578</c:v>
                </c:pt>
                <c:pt idx="176">
                  <c:v>2.878657</c:v>
                </c:pt>
                <c:pt idx="177">
                  <c:v>2.8892440000000001</c:v>
                </c:pt>
                <c:pt idx="178">
                  <c:v>2.8990140000000002</c:v>
                </c:pt>
                <c:pt idx="179">
                  <c:v>2.912585</c:v>
                </c:pt>
                <c:pt idx="180">
                  <c:v>2.9280789999999999</c:v>
                </c:pt>
                <c:pt idx="181">
                  <c:v>2.9471530000000001</c:v>
                </c:pt>
                <c:pt idx="182">
                  <c:v>2.9627210000000002</c:v>
                </c:pt>
                <c:pt idx="183">
                  <c:v>2.9769169999999998</c:v>
                </c:pt>
                <c:pt idx="184">
                  <c:v>2.9925120000000001</c:v>
                </c:pt>
                <c:pt idx="185">
                  <c:v>3.0079389999999999</c:v>
                </c:pt>
                <c:pt idx="186">
                  <c:v>3.0233530000000002</c:v>
                </c:pt>
                <c:pt idx="187">
                  <c:v>3.0401319999999998</c:v>
                </c:pt>
                <c:pt idx="188">
                  <c:v>3.056403</c:v>
                </c:pt>
                <c:pt idx="189">
                  <c:v>3.0721029999999998</c:v>
                </c:pt>
                <c:pt idx="190">
                  <c:v>3.0837639999999999</c:v>
                </c:pt>
                <c:pt idx="191">
                  <c:v>3.0932469999999999</c:v>
                </c:pt>
                <c:pt idx="192">
                  <c:v>3.102957</c:v>
                </c:pt>
                <c:pt idx="193">
                  <c:v>3.1145879999999999</c:v>
                </c:pt>
                <c:pt idx="194">
                  <c:v>3.1312479999999998</c:v>
                </c:pt>
                <c:pt idx="195">
                  <c:v>3.1454680000000002</c:v>
                </c:pt>
                <c:pt idx="196">
                  <c:v>3.1581959999999998</c:v>
                </c:pt>
                <c:pt idx="197">
                  <c:v>3.1699989999999998</c:v>
                </c:pt>
                <c:pt idx="198">
                  <c:v>3.1823830000000002</c:v>
                </c:pt>
                <c:pt idx="199">
                  <c:v>3.195478</c:v>
                </c:pt>
                <c:pt idx="200">
                  <c:v>3.2057989999999998</c:v>
                </c:pt>
                <c:pt idx="201">
                  <c:v>3.2131479999999999</c:v>
                </c:pt>
                <c:pt idx="202">
                  <c:v>3.2198129999999998</c:v>
                </c:pt>
                <c:pt idx="203">
                  <c:v>3.22919</c:v>
                </c:pt>
                <c:pt idx="204">
                  <c:v>3.2411560000000001</c:v>
                </c:pt>
                <c:pt idx="205">
                  <c:v>3.2516349999999998</c:v>
                </c:pt>
                <c:pt idx="206">
                  <c:v>3.2579859999999998</c:v>
                </c:pt>
                <c:pt idx="207">
                  <c:v>3.2617229999999999</c:v>
                </c:pt>
                <c:pt idx="208">
                  <c:v>3.2629250000000001</c:v>
                </c:pt>
                <c:pt idx="209">
                  <c:v>3.265638</c:v>
                </c:pt>
                <c:pt idx="210">
                  <c:v>3.2704059999999999</c:v>
                </c:pt>
                <c:pt idx="211">
                  <c:v>3.274762</c:v>
                </c:pt>
                <c:pt idx="212">
                  <c:v>3.276958</c:v>
                </c:pt>
                <c:pt idx="213">
                  <c:v>3.27929</c:v>
                </c:pt>
                <c:pt idx="214">
                  <c:v>3.2823660000000001</c:v>
                </c:pt>
                <c:pt idx="215">
                  <c:v>3.2819660000000002</c:v>
                </c:pt>
                <c:pt idx="216">
                  <c:v>3.2790859999999999</c:v>
                </c:pt>
                <c:pt idx="217">
                  <c:v>3.2729949999999999</c:v>
                </c:pt>
                <c:pt idx="218">
                  <c:v>3.2683430000000002</c:v>
                </c:pt>
                <c:pt idx="219">
                  <c:v>3.2639990000000001</c:v>
                </c:pt>
                <c:pt idx="220">
                  <c:v>3.2588979999999999</c:v>
                </c:pt>
                <c:pt idx="221">
                  <c:v>3.252891</c:v>
                </c:pt>
                <c:pt idx="222">
                  <c:v>3.239805</c:v>
                </c:pt>
                <c:pt idx="223">
                  <c:v>3.2247840000000001</c:v>
                </c:pt>
                <c:pt idx="224">
                  <c:v>3.210874</c:v>
                </c:pt>
                <c:pt idx="225">
                  <c:v>3.1946400000000001</c:v>
                </c:pt>
                <c:pt idx="226">
                  <c:v>3.1805300000000001</c:v>
                </c:pt>
                <c:pt idx="227">
                  <c:v>3.1594310000000001</c:v>
                </c:pt>
                <c:pt idx="228">
                  <c:v>3.1354350000000002</c:v>
                </c:pt>
                <c:pt idx="229">
                  <c:v>3.1136020000000002</c:v>
                </c:pt>
                <c:pt idx="230">
                  <c:v>3.0921270000000001</c:v>
                </c:pt>
                <c:pt idx="231">
                  <c:v>3.0714459999999999</c:v>
                </c:pt>
                <c:pt idx="232">
                  <c:v>3.0501580000000001</c:v>
                </c:pt>
                <c:pt idx="233">
                  <c:v>3.0321150000000001</c:v>
                </c:pt>
                <c:pt idx="234">
                  <c:v>3.010173</c:v>
                </c:pt>
                <c:pt idx="235">
                  <c:v>2.984896</c:v>
                </c:pt>
                <c:pt idx="236">
                  <c:v>2.9603440000000001</c:v>
                </c:pt>
                <c:pt idx="237">
                  <c:v>2.9298109999999999</c:v>
                </c:pt>
                <c:pt idx="238">
                  <c:v>2.905052</c:v>
                </c:pt>
                <c:pt idx="239">
                  <c:v>2.8767469999999999</c:v>
                </c:pt>
                <c:pt idx="240">
                  <c:v>2.845386</c:v>
                </c:pt>
                <c:pt idx="241">
                  <c:v>2.813294</c:v>
                </c:pt>
                <c:pt idx="242">
                  <c:v>2.774597</c:v>
                </c:pt>
                <c:pt idx="243">
                  <c:v>2.7434599999999998</c:v>
                </c:pt>
                <c:pt idx="244">
                  <c:v>2.705994</c:v>
                </c:pt>
                <c:pt idx="245">
                  <c:v>2.6701199999999998</c:v>
                </c:pt>
                <c:pt idx="246">
                  <c:v>2.632457</c:v>
                </c:pt>
                <c:pt idx="247">
                  <c:v>2.596597</c:v>
                </c:pt>
                <c:pt idx="248">
                  <c:v>2.5605549999999999</c:v>
                </c:pt>
                <c:pt idx="249">
                  <c:v>2.5218039999999999</c:v>
                </c:pt>
                <c:pt idx="250">
                  <c:v>2.4784090000000001</c:v>
                </c:pt>
                <c:pt idx="251">
                  <c:v>2.437351</c:v>
                </c:pt>
                <c:pt idx="252">
                  <c:v>2.3980739999999998</c:v>
                </c:pt>
                <c:pt idx="253">
                  <c:v>2.3642180000000002</c:v>
                </c:pt>
                <c:pt idx="254">
                  <c:v>2.3279049999999999</c:v>
                </c:pt>
                <c:pt idx="255">
                  <c:v>2.2870970000000002</c:v>
                </c:pt>
                <c:pt idx="256">
                  <c:v>2.2436310000000002</c:v>
                </c:pt>
                <c:pt idx="257">
                  <c:v>2.1998579999999999</c:v>
                </c:pt>
                <c:pt idx="258">
                  <c:v>2.1615980000000001</c:v>
                </c:pt>
                <c:pt idx="259">
                  <c:v>2.1162700000000001</c:v>
                </c:pt>
                <c:pt idx="260">
                  <c:v>2.0704509999999998</c:v>
                </c:pt>
                <c:pt idx="261">
                  <c:v>2.0244689999999999</c:v>
                </c:pt>
                <c:pt idx="262">
                  <c:v>1.9858130000000001</c:v>
                </c:pt>
                <c:pt idx="263">
                  <c:v>1.9524490000000001</c:v>
                </c:pt>
                <c:pt idx="264">
                  <c:v>1.9120900000000001</c:v>
                </c:pt>
                <c:pt idx="265">
                  <c:v>1.8723609999999999</c:v>
                </c:pt>
                <c:pt idx="266">
                  <c:v>1.831337</c:v>
                </c:pt>
                <c:pt idx="267">
                  <c:v>1.7949059999999999</c:v>
                </c:pt>
                <c:pt idx="268">
                  <c:v>1.758877</c:v>
                </c:pt>
                <c:pt idx="269">
                  <c:v>1.717465</c:v>
                </c:pt>
                <c:pt idx="270">
                  <c:v>1.676749</c:v>
                </c:pt>
                <c:pt idx="271">
                  <c:v>1.6409990000000001</c:v>
                </c:pt>
                <c:pt idx="272">
                  <c:v>1.6007899999999999</c:v>
                </c:pt>
                <c:pt idx="273">
                  <c:v>1.561404</c:v>
                </c:pt>
                <c:pt idx="274">
                  <c:v>1.520599</c:v>
                </c:pt>
                <c:pt idx="275">
                  <c:v>1.4842630000000001</c:v>
                </c:pt>
                <c:pt idx="276">
                  <c:v>1.4480170000000001</c:v>
                </c:pt>
                <c:pt idx="277">
                  <c:v>1.4106639999999999</c:v>
                </c:pt>
                <c:pt idx="278">
                  <c:v>1.376336</c:v>
                </c:pt>
                <c:pt idx="279">
                  <c:v>1.34453</c:v>
                </c:pt>
                <c:pt idx="280">
                  <c:v>1.3132630000000001</c:v>
                </c:pt>
                <c:pt idx="281">
                  <c:v>1.28339</c:v>
                </c:pt>
                <c:pt idx="282">
                  <c:v>1.2446759999999999</c:v>
                </c:pt>
                <c:pt idx="283">
                  <c:v>1.2074180000000001</c:v>
                </c:pt>
                <c:pt idx="284">
                  <c:v>1.1744270000000001</c:v>
                </c:pt>
                <c:pt idx="285">
                  <c:v>1.1431849999999999</c:v>
                </c:pt>
                <c:pt idx="286">
                  <c:v>1.1126529999999999</c:v>
                </c:pt>
                <c:pt idx="287">
                  <c:v>1.07982</c:v>
                </c:pt>
                <c:pt idx="288">
                  <c:v>1.049647</c:v>
                </c:pt>
                <c:pt idx="289">
                  <c:v>1.0206869999999999</c:v>
                </c:pt>
                <c:pt idx="290">
                  <c:v>0.99066600000000005</c:v>
                </c:pt>
                <c:pt idx="291">
                  <c:v>0.96037899999999998</c:v>
                </c:pt>
                <c:pt idx="292">
                  <c:v>0.93325899999999995</c:v>
                </c:pt>
                <c:pt idx="293">
                  <c:v>0.90733299999999995</c:v>
                </c:pt>
                <c:pt idx="294">
                  <c:v>0.87887599999999999</c:v>
                </c:pt>
                <c:pt idx="295">
                  <c:v>0.85245800000000005</c:v>
                </c:pt>
                <c:pt idx="296">
                  <c:v>0.82618000000000003</c:v>
                </c:pt>
                <c:pt idx="297">
                  <c:v>0.80291500000000005</c:v>
                </c:pt>
                <c:pt idx="298">
                  <c:v>0.78082799999999997</c:v>
                </c:pt>
                <c:pt idx="299">
                  <c:v>0.75556000000000001</c:v>
                </c:pt>
                <c:pt idx="300">
                  <c:v>0.73329800000000001</c:v>
                </c:pt>
                <c:pt idx="301">
                  <c:v>0.71357000000000004</c:v>
                </c:pt>
                <c:pt idx="302">
                  <c:v>0.69093800000000005</c:v>
                </c:pt>
                <c:pt idx="303">
                  <c:v>0.67459999999999998</c:v>
                </c:pt>
                <c:pt idx="304">
                  <c:v>0.65528299999999995</c:v>
                </c:pt>
                <c:pt idx="305">
                  <c:v>0.63181399999999999</c:v>
                </c:pt>
                <c:pt idx="306">
                  <c:v>0.61355300000000002</c:v>
                </c:pt>
                <c:pt idx="307">
                  <c:v>0.58803499999999997</c:v>
                </c:pt>
                <c:pt idx="308">
                  <c:v>0.56271199999999999</c:v>
                </c:pt>
                <c:pt idx="309">
                  <c:v>0.54271899999999995</c:v>
                </c:pt>
                <c:pt idx="310">
                  <c:v>0.52436099999999997</c:v>
                </c:pt>
                <c:pt idx="311">
                  <c:v>0.50791600000000003</c:v>
                </c:pt>
                <c:pt idx="312">
                  <c:v>0.49251</c:v>
                </c:pt>
                <c:pt idx="313">
                  <c:v>0.47413</c:v>
                </c:pt>
                <c:pt idx="314">
                  <c:v>0.45945000000000003</c:v>
                </c:pt>
                <c:pt idx="315">
                  <c:v>0.44533299999999998</c:v>
                </c:pt>
                <c:pt idx="316">
                  <c:v>0.430145</c:v>
                </c:pt>
                <c:pt idx="317">
                  <c:v>0.41589500000000001</c:v>
                </c:pt>
                <c:pt idx="318">
                  <c:v>0.40052199999999999</c:v>
                </c:pt>
                <c:pt idx="319">
                  <c:v>0.383299</c:v>
                </c:pt>
                <c:pt idx="320">
                  <c:v>0.371282</c:v>
                </c:pt>
                <c:pt idx="321">
                  <c:v>0.359705</c:v>
                </c:pt>
                <c:pt idx="322">
                  <c:v>0.34655399999999997</c:v>
                </c:pt>
                <c:pt idx="323">
                  <c:v>0.33855600000000002</c:v>
                </c:pt>
                <c:pt idx="324">
                  <c:v>0.329648</c:v>
                </c:pt>
                <c:pt idx="325">
                  <c:v>0.32186900000000002</c:v>
                </c:pt>
                <c:pt idx="326">
                  <c:v>0.30952000000000002</c:v>
                </c:pt>
                <c:pt idx="327">
                  <c:v>0.29566999999999999</c:v>
                </c:pt>
                <c:pt idx="328">
                  <c:v>0.27856700000000001</c:v>
                </c:pt>
                <c:pt idx="329">
                  <c:v>0.26333000000000001</c:v>
                </c:pt>
                <c:pt idx="330">
                  <c:v>0.25487799999999999</c:v>
                </c:pt>
                <c:pt idx="331">
                  <c:v>0.245335</c:v>
                </c:pt>
                <c:pt idx="332">
                  <c:v>0.24149999999999999</c:v>
                </c:pt>
                <c:pt idx="333">
                  <c:v>0.233762</c:v>
                </c:pt>
                <c:pt idx="334">
                  <c:v>0.22731199999999999</c:v>
                </c:pt>
                <c:pt idx="335">
                  <c:v>0.225102</c:v>
                </c:pt>
                <c:pt idx="336">
                  <c:v>0.21968599999999999</c:v>
                </c:pt>
                <c:pt idx="337">
                  <c:v>0.208371</c:v>
                </c:pt>
                <c:pt idx="338">
                  <c:v>0.190775</c:v>
                </c:pt>
                <c:pt idx="339">
                  <c:v>0.18040600000000001</c:v>
                </c:pt>
                <c:pt idx="340">
                  <c:v>0.17684</c:v>
                </c:pt>
                <c:pt idx="341">
                  <c:v>0.177733</c:v>
                </c:pt>
                <c:pt idx="342">
                  <c:v>0.172873</c:v>
                </c:pt>
                <c:pt idx="343">
                  <c:v>0.164634</c:v>
                </c:pt>
                <c:pt idx="344">
                  <c:v>0.158001</c:v>
                </c:pt>
                <c:pt idx="345">
                  <c:v>0.154279</c:v>
                </c:pt>
                <c:pt idx="346">
                  <c:v>0.153616</c:v>
                </c:pt>
                <c:pt idx="347">
                  <c:v>0.15220400000000001</c:v>
                </c:pt>
                <c:pt idx="348">
                  <c:v>0.15071699999999999</c:v>
                </c:pt>
                <c:pt idx="349">
                  <c:v>0.14530100000000001</c:v>
                </c:pt>
                <c:pt idx="350">
                  <c:v>0.14124700000000001</c:v>
                </c:pt>
                <c:pt idx="351">
                  <c:v>0.13104499999999999</c:v>
                </c:pt>
                <c:pt idx="352">
                  <c:v>0.11609</c:v>
                </c:pt>
                <c:pt idx="353">
                  <c:v>0.10389900000000001</c:v>
                </c:pt>
                <c:pt idx="354">
                  <c:v>9.7895999999999997E-2</c:v>
                </c:pt>
                <c:pt idx="355">
                  <c:v>0.101188</c:v>
                </c:pt>
                <c:pt idx="356">
                  <c:v>0.104307</c:v>
                </c:pt>
                <c:pt idx="357">
                  <c:v>0.103145</c:v>
                </c:pt>
                <c:pt idx="358">
                  <c:v>9.9972000000000005E-2</c:v>
                </c:pt>
                <c:pt idx="359">
                  <c:v>0.100491</c:v>
                </c:pt>
                <c:pt idx="360">
                  <c:v>0.103176</c:v>
                </c:pt>
                <c:pt idx="361">
                  <c:v>9.7907999999999995E-2</c:v>
                </c:pt>
                <c:pt idx="362">
                  <c:v>9.1540999999999997E-2</c:v>
                </c:pt>
                <c:pt idx="363">
                  <c:v>8.2979999999999998E-2</c:v>
                </c:pt>
                <c:pt idx="364">
                  <c:v>7.8595999999999999E-2</c:v>
                </c:pt>
                <c:pt idx="365">
                  <c:v>7.6037999999999994E-2</c:v>
                </c:pt>
                <c:pt idx="366">
                  <c:v>7.4255000000000002E-2</c:v>
                </c:pt>
                <c:pt idx="367">
                  <c:v>7.2583999999999996E-2</c:v>
                </c:pt>
                <c:pt idx="368">
                  <c:v>7.3746000000000006E-2</c:v>
                </c:pt>
                <c:pt idx="369">
                  <c:v>7.671E-2</c:v>
                </c:pt>
                <c:pt idx="370">
                  <c:v>7.3667999999999997E-2</c:v>
                </c:pt>
                <c:pt idx="371">
                  <c:v>7.1249000000000007E-2</c:v>
                </c:pt>
                <c:pt idx="372">
                  <c:v>6.7561999999999997E-2</c:v>
                </c:pt>
                <c:pt idx="373">
                  <c:v>5.9214999999999997E-2</c:v>
                </c:pt>
                <c:pt idx="374">
                  <c:v>5.7109E-2</c:v>
                </c:pt>
                <c:pt idx="375">
                  <c:v>5.1323000000000001E-2</c:v>
                </c:pt>
                <c:pt idx="376">
                  <c:v>4.9461999999999999E-2</c:v>
                </c:pt>
                <c:pt idx="377">
                  <c:v>5.1000999999999998E-2</c:v>
                </c:pt>
                <c:pt idx="378">
                  <c:v>4.9619999999999997E-2</c:v>
                </c:pt>
                <c:pt idx="379">
                  <c:v>4.7101999999999998E-2</c:v>
                </c:pt>
                <c:pt idx="380">
                  <c:v>3.9315000000000003E-2</c:v>
                </c:pt>
                <c:pt idx="381">
                  <c:v>4.3404999999999999E-2</c:v>
                </c:pt>
                <c:pt idx="382">
                  <c:v>4.2615E-2</c:v>
                </c:pt>
                <c:pt idx="383">
                  <c:v>4.5784999999999999E-2</c:v>
                </c:pt>
                <c:pt idx="384">
                  <c:v>4.1034000000000001E-2</c:v>
                </c:pt>
                <c:pt idx="385">
                  <c:v>3.1583E-2</c:v>
                </c:pt>
                <c:pt idx="386">
                  <c:v>3.1185999999999998E-2</c:v>
                </c:pt>
                <c:pt idx="387">
                  <c:v>3.3304E-2</c:v>
                </c:pt>
                <c:pt idx="388">
                  <c:v>3.6711000000000001E-2</c:v>
                </c:pt>
                <c:pt idx="389">
                  <c:v>3.7130000000000003E-2</c:v>
                </c:pt>
                <c:pt idx="390">
                  <c:v>3.6505000000000003E-2</c:v>
                </c:pt>
                <c:pt idx="391">
                  <c:v>3.8227999999999998E-2</c:v>
                </c:pt>
                <c:pt idx="392">
                  <c:v>3.6739000000000001E-2</c:v>
                </c:pt>
                <c:pt idx="393">
                  <c:v>3.5841999999999999E-2</c:v>
                </c:pt>
                <c:pt idx="394">
                  <c:v>3.1777E-2</c:v>
                </c:pt>
                <c:pt idx="395">
                  <c:v>2.9648999999999998E-2</c:v>
                </c:pt>
                <c:pt idx="396">
                  <c:v>2.8167000000000001E-2</c:v>
                </c:pt>
                <c:pt idx="397">
                  <c:v>3.1581999999999999E-2</c:v>
                </c:pt>
                <c:pt idx="398">
                  <c:v>3.5980999999999999E-2</c:v>
                </c:pt>
                <c:pt idx="399">
                  <c:v>3.5519000000000002E-2</c:v>
                </c:pt>
                <c:pt idx="400">
                  <c:v>3.858000000000000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7EA-427F-9331-D16DB05BFE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1079071"/>
        <c:axId val="181079487"/>
      </c:lineChart>
      <c:catAx>
        <c:axId val="18107907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079487"/>
        <c:crosses val="autoZero"/>
        <c:auto val="1"/>
        <c:lblAlgn val="ctr"/>
        <c:lblOffset val="100"/>
        <c:tickLblSkip val="20"/>
        <c:tickMarkSkip val="20"/>
        <c:noMultiLvlLbl val="0"/>
      </c:catAx>
      <c:valAx>
        <c:axId val="181079487"/>
        <c:scaling>
          <c:orientation val="minMax"/>
          <c:max val="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1079071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8013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7288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2425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4066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9084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250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1470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3293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3892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6736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040483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57BB2A-7459-4DFB-B08C-25C48D2021C8}" type="datetimeFigureOut">
              <a:rPr lang="es-ES" smtClean="0"/>
              <a:t>19/1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45990-B3D1-49BF-ACCC-820098A685E3}" type="slidenum">
              <a:rPr lang="es-ES" smtClean="0"/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2129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4">
            <a:extLst>
              <a:ext uri="{FF2B5EF4-FFF2-40B4-BE49-F238E27FC236}">
                <a16:creationId xmlns:a16="http://schemas.microsoft.com/office/drawing/2014/main" id="{DD5276D5-764E-91B2-EAD9-F101B42B8C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4982" y="1686814"/>
            <a:ext cx="4778631" cy="7725199"/>
          </a:xfrm>
          <a:prstGeom prst="rect">
            <a:avLst/>
          </a:prstGeom>
        </p:spPr>
      </p:pic>
      <p:sp>
        <p:nvSpPr>
          <p:cNvPr id="5" name="CasellaDiTesto 7">
            <a:extLst>
              <a:ext uri="{FF2B5EF4-FFF2-40B4-BE49-F238E27FC236}">
                <a16:creationId xmlns:a16="http://schemas.microsoft.com/office/drawing/2014/main" id="{9295D1E4-7BAE-0BAA-6D1F-F67B1FDF06D1}"/>
              </a:ext>
            </a:extLst>
          </p:cNvPr>
          <p:cNvSpPr txBox="1"/>
          <p:nvPr/>
        </p:nvSpPr>
        <p:spPr>
          <a:xfrm>
            <a:off x="0" y="0"/>
            <a:ext cx="2270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48548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7">
            <a:extLst>
              <a:ext uri="{FF2B5EF4-FFF2-40B4-BE49-F238E27FC236}">
                <a16:creationId xmlns:a16="http://schemas.microsoft.com/office/drawing/2014/main" id="{E8F649E5-D3D1-70D3-CECB-E2BFB36AE154}"/>
              </a:ext>
            </a:extLst>
          </p:cNvPr>
          <p:cNvSpPr txBox="1"/>
          <p:nvPr/>
        </p:nvSpPr>
        <p:spPr>
          <a:xfrm>
            <a:off x="-1" y="0"/>
            <a:ext cx="24647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it-IT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upo 6">
            <a:extLst>
              <a:ext uri="{FF2B5EF4-FFF2-40B4-BE49-F238E27FC236}">
                <a16:creationId xmlns:a16="http://schemas.microsoft.com/office/drawing/2014/main" id="{8F6B4E03-3F59-C5E4-B2E5-0F689BD5765A}"/>
              </a:ext>
            </a:extLst>
          </p:cNvPr>
          <p:cNvGrpSpPr/>
          <p:nvPr/>
        </p:nvGrpSpPr>
        <p:grpSpPr>
          <a:xfrm>
            <a:off x="761600" y="1812410"/>
            <a:ext cx="5334799" cy="3310354"/>
            <a:chOff x="3219217" y="2018923"/>
            <a:chExt cx="5334799" cy="3310354"/>
          </a:xfrm>
        </p:grpSpPr>
        <p:graphicFrame>
          <p:nvGraphicFramePr>
            <p:cNvPr id="4" name="Gráfico 3">
              <a:extLst>
                <a:ext uri="{FF2B5EF4-FFF2-40B4-BE49-F238E27FC236}">
                  <a16:creationId xmlns:a16="http://schemas.microsoft.com/office/drawing/2014/main" id="{52EF2034-3193-0445-C9F0-3CDC24A1FF3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24494816"/>
                </p:ext>
              </p:extLst>
            </p:nvPr>
          </p:nvGraphicFramePr>
          <p:xfrm>
            <a:off x="3558012" y="2018923"/>
            <a:ext cx="4996004" cy="2971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0433D71E-8850-8DEC-7F73-E4A56C986FA9}"/>
                </a:ext>
              </a:extLst>
            </p:cNvPr>
            <p:cNvSpPr txBox="1"/>
            <p:nvPr/>
          </p:nvSpPr>
          <p:spPr>
            <a:xfrm>
              <a:off x="5247716" y="4990723"/>
              <a:ext cx="1616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avelength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98108D1F-2BF6-47AE-6B58-00358671996E}"/>
                </a:ext>
              </a:extLst>
            </p:cNvPr>
            <p:cNvSpPr txBox="1"/>
            <p:nvPr/>
          </p:nvSpPr>
          <p:spPr>
            <a:xfrm rot="16200000">
              <a:off x="2423037" y="3335547"/>
              <a:ext cx="19309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rradiance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s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W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m</a:t>
              </a:r>
              <a:r>
                <a:rPr lang="es-ES" sz="16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s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12552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1">
            <a:extLst>
              <a:ext uri="{FF2B5EF4-FFF2-40B4-BE49-F238E27FC236}">
                <a16:creationId xmlns:a16="http://schemas.microsoft.com/office/drawing/2014/main" id="{9E16955C-1AA1-1E6F-B063-AAD54889B1D0}"/>
              </a:ext>
            </a:extLst>
          </p:cNvPr>
          <p:cNvSpPr/>
          <p:nvPr/>
        </p:nvSpPr>
        <p:spPr>
          <a:xfrm>
            <a:off x="1844522" y="1810048"/>
            <a:ext cx="4219105" cy="1905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CuadroTexto 126">
            <a:extLst>
              <a:ext uri="{FF2B5EF4-FFF2-40B4-BE49-F238E27FC236}">
                <a16:creationId xmlns:a16="http://schemas.microsoft.com/office/drawing/2014/main" id="{66602416-D96A-8AB1-913D-13533F2207D2}"/>
              </a:ext>
            </a:extLst>
          </p:cNvPr>
          <p:cNvSpPr txBox="1"/>
          <p:nvPr/>
        </p:nvSpPr>
        <p:spPr>
          <a:xfrm>
            <a:off x="1709737" y="2298244"/>
            <a:ext cx="4830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5        4          7.5          12            16               20         24.5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ttangolo 5">
            <a:extLst>
              <a:ext uri="{FF2B5EF4-FFF2-40B4-BE49-F238E27FC236}">
                <a16:creationId xmlns:a16="http://schemas.microsoft.com/office/drawing/2014/main" id="{4F9B49C2-25FE-3BF1-CA4C-E74382293FAC}"/>
              </a:ext>
            </a:extLst>
          </p:cNvPr>
          <p:cNvSpPr/>
          <p:nvPr/>
        </p:nvSpPr>
        <p:spPr>
          <a:xfrm>
            <a:off x="3413055" y="1812152"/>
            <a:ext cx="2297238" cy="18719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CasellaDiTesto 6">
            <a:extLst>
              <a:ext uri="{FF2B5EF4-FFF2-40B4-BE49-F238E27FC236}">
                <a16:creationId xmlns:a16="http://schemas.microsoft.com/office/drawing/2014/main" id="{6E90895D-7F7A-48B7-A404-485CF2D0D935}"/>
              </a:ext>
            </a:extLst>
          </p:cNvPr>
          <p:cNvSpPr txBox="1"/>
          <p:nvPr/>
        </p:nvSpPr>
        <p:spPr>
          <a:xfrm>
            <a:off x="558183" y="2298244"/>
            <a:ext cx="11124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ZT time (h)</a:t>
            </a:r>
          </a:p>
        </p:txBody>
      </p:sp>
      <p:sp>
        <p:nvSpPr>
          <p:cNvPr id="9" name="CasellaDiTesto 7">
            <a:extLst>
              <a:ext uri="{FF2B5EF4-FFF2-40B4-BE49-F238E27FC236}">
                <a16:creationId xmlns:a16="http://schemas.microsoft.com/office/drawing/2014/main" id="{66176685-1D54-B111-E3F9-1E22D85072A3}"/>
              </a:ext>
            </a:extLst>
          </p:cNvPr>
          <p:cNvSpPr txBox="1"/>
          <p:nvPr/>
        </p:nvSpPr>
        <p:spPr>
          <a:xfrm>
            <a:off x="692426" y="1747180"/>
            <a:ext cx="11124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:14 LD</a:t>
            </a:r>
          </a:p>
        </p:txBody>
      </p:sp>
      <p:cxnSp>
        <p:nvCxnSpPr>
          <p:cNvPr id="10" name="Connettore diritto 14">
            <a:extLst>
              <a:ext uri="{FF2B5EF4-FFF2-40B4-BE49-F238E27FC236}">
                <a16:creationId xmlns:a16="http://schemas.microsoft.com/office/drawing/2014/main" id="{B7EF2524-6A2F-DEA8-3E86-F45A631A01EA}"/>
              </a:ext>
            </a:extLst>
          </p:cNvPr>
          <p:cNvCxnSpPr>
            <a:cxnSpLocks/>
          </p:cNvCxnSpPr>
          <p:nvPr/>
        </p:nvCxnSpPr>
        <p:spPr>
          <a:xfrm>
            <a:off x="1977079" y="2009505"/>
            <a:ext cx="0" cy="248846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1" name="Connettore diritto 16">
            <a:extLst>
              <a:ext uri="{FF2B5EF4-FFF2-40B4-BE49-F238E27FC236}">
                <a16:creationId xmlns:a16="http://schemas.microsoft.com/office/drawing/2014/main" id="{F3E2930F-44C7-1004-AF02-8BD2E0CC6894}"/>
              </a:ext>
            </a:extLst>
          </p:cNvPr>
          <p:cNvCxnSpPr>
            <a:cxnSpLocks/>
          </p:cNvCxnSpPr>
          <p:nvPr/>
        </p:nvCxnSpPr>
        <p:spPr>
          <a:xfrm>
            <a:off x="2464759" y="2009505"/>
            <a:ext cx="0" cy="248846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2" name="Connettore diritto 17">
            <a:extLst>
              <a:ext uri="{FF2B5EF4-FFF2-40B4-BE49-F238E27FC236}">
                <a16:creationId xmlns:a16="http://schemas.microsoft.com/office/drawing/2014/main" id="{E32A658D-7CAD-77E2-6B57-4304512021C8}"/>
              </a:ext>
            </a:extLst>
          </p:cNvPr>
          <p:cNvCxnSpPr>
            <a:cxnSpLocks/>
          </p:cNvCxnSpPr>
          <p:nvPr/>
        </p:nvCxnSpPr>
        <p:spPr>
          <a:xfrm>
            <a:off x="3074359" y="2004499"/>
            <a:ext cx="0" cy="248846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3" name="Connettore diritto 18">
            <a:extLst>
              <a:ext uri="{FF2B5EF4-FFF2-40B4-BE49-F238E27FC236}">
                <a16:creationId xmlns:a16="http://schemas.microsoft.com/office/drawing/2014/main" id="{42196E7D-AA2F-B903-EF0E-1B9DF312C42D}"/>
              </a:ext>
            </a:extLst>
          </p:cNvPr>
          <p:cNvCxnSpPr>
            <a:cxnSpLocks/>
          </p:cNvCxnSpPr>
          <p:nvPr/>
        </p:nvCxnSpPr>
        <p:spPr>
          <a:xfrm>
            <a:off x="3714439" y="1999345"/>
            <a:ext cx="0" cy="248846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4" name="Connettore diritto 19">
            <a:extLst>
              <a:ext uri="{FF2B5EF4-FFF2-40B4-BE49-F238E27FC236}">
                <a16:creationId xmlns:a16="http://schemas.microsoft.com/office/drawing/2014/main" id="{C9635208-3638-2E8B-DDED-965003D02743}"/>
              </a:ext>
            </a:extLst>
          </p:cNvPr>
          <p:cNvCxnSpPr>
            <a:cxnSpLocks/>
          </p:cNvCxnSpPr>
          <p:nvPr/>
        </p:nvCxnSpPr>
        <p:spPr>
          <a:xfrm>
            <a:off x="4425639" y="2000548"/>
            <a:ext cx="0" cy="248846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5" name="Connettore diritto 20">
            <a:extLst>
              <a:ext uri="{FF2B5EF4-FFF2-40B4-BE49-F238E27FC236}">
                <a16:creationId xmlns:a16="http://schemas.microsoft.com/office/drawing/2014/main" id="{2F884779-9AC6-BFF2-AB9E-086734974B15}"/>
              </a:ext>
            </a:extLst>
          </p:cNvPr>
          <p:cNvCxnSpPr>
            <a:cxnSpLocks/>
          </p:cNvCxnSpPr>
          <p:nvPr/>
        </p:nvCxnSpPr>
        <p:spPr>
          <a:xfrm>
            <a:off x="5258759" y="2009505"/>
            <a:ext cx="0" cy="248846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6" name="Connettore diritto 21">
            <a:extLst>
              <a:ext uri="{FF2B5EF4-FFF2-40B4-BE49-F238E27FC236}">
                <a16:creationId xmlns:a16="http://schemas.microsoft.com/office/drawing/2014/main" id="{92D9DD9B-4B2D-1141-CD98-49B80D277312}"/>
              </a:ext>
            </a:extLst>
          </p:cNvPr>
          <p:cNvCxnSpPr>
            <a:cxnSpLocks/>
          </p:cNvCxnSpPr>
          <p:nvPr/>
        </p:nvCxnSpPr>
        <p:spPr>
          <a:xfrm>
            <a:off x="5878519" y="2014659"/>
            <a:ext cx="0" cy="248846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7" name="CasellaDiTesto 7">
            <a:extLst>
              <a:ext uri="{FF2B5EF4-FFF2-40B4-BE49-F238E27FC236}">
                <a16:creationId xmlns:a16="http://schemas.microsoft.com/office/drawing/2014/main" id="{9295D1E4-7BAE-0BAA-6D1F-F67B1FDF06D1}"/>
              </a:ext>
            </a:extLst>
          </p:cNvPr>
          <p:cNvSpPr txBox="1"/>
          <p:nvPr/>
        </p:nvSpPr>
        <p:spPr>
          <a:xfrm>
            <a:off x="-1" y="0"/>
            <a:ext cx="24647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42453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</Words>
  <Application>Microsoft Office PowerPoint</Application>
  <PresentationFormat>Widescreen</PresentationFormat>
  <Paragraphs>8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e Office</vt:lpstr>
      <vt:lpstr>Presentazione standard di PowerPoint</vt:lpstr>
      <vt:lpstr>Presentazione standard di PowerPoint</vt:lpstr>
      <vt:lpstr>Presentazione standard di PowerPoint</vt:lpstr>
    </vt:vector>
  </TitlesOfParts>
  <Company>Universidad de Murc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sé Fernando López Olmeda</dc:creator>
  <cp:lastModifiedBy>Elisa Samori</cp:lastModifiedBy>
  <cp:revision>8</cp:revision>
  <dcterms:created xsi:type="dcterms:W3CDTF">2024-02-20T16:07:20Z</dcterms:created>
  <dcterms:modified xsi:type="dcterms:W3CDTF">2024-12-19T16:29:39Z</dcterms:modified>
</cp:coreProperties>
</file>